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7"/>
  </p:notesMasterIdLst>
  <p:sldIdLst>
    <p:sldId id="262" r:id="rId2"/>
    <p:sldId id="260" r:id="rId3"/>
    <p:sldId id="257" r:id="rId4"/>
    <p:sldId id="256" r:id="rId5"/>
    <p:sldId id="261" r:id="rId6"/>
  </p:sldIdLst>
  <p:sldSz cx="6858000" cy="9902825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7" d="100"/>
          <a:sy n="117" d="100"/>
        </p:scale>
        <p:origin x="4088" y="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  <a:t>2025/10/2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461" y="1143000"/>
            <a:ext cx="2137079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19404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857250" y="1620798"/>
            <a:ext cx="5143500" cy="344792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57250" y="5201683"/>
            <a:ext cx="5143500" cy="23910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194346-F981-468E-BB97-94E9A093B877}" type="datetimeFigureOut">
              <a:rPr lang="zh-CN" altLang="en-US" smtClean="0"/>
              <a:t>2025/10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90CBD-2EAC-430E-9E04-162544A6F47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194346-F981-468E-BB97-94E9A093B877}" type="datetimeFigureOut">
              <a:rPr lang="zh-CN" altLang="en-US" smtClean="0"/>
              <a:t>2025/10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90CBD-2EAC-430E-9E04-162544A6F47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07756" y="527275"/>
            <a:ext cx="1478756" cy="839284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71488" y="527275"/>
            <a:ext cx="4350544" cy="839284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194346-F981-468E-BB97-94E9A093B877}" type="datetimeFigureOut">
              <a:rPr lang="zh-CN" altLang="en-US" smtClean="0"/>
              <a:t>2025/10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90CBD-2EAC-430E-9E04-162544A6F47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194346-F981-468E-BB97-94E9A093B877}" type="datetimeFigureOut">
              <a:rPr lang="zh-CN" altLang="en-US" smtClean="0"/>
              <a:t>2025/10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90CBD-2EAC-430E-9E04-162544A6F47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67916" y="2469023"/>
            <a:ext cx="5915025" cy="411962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67916" y="6627618"/>
            <a:ext cx="5915025" cy="2166412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194346-F981-468E-BB97-94E9A093B877}" type="datetimeFigureOut">
              <a:rPr lang="zh-CN" altLang="en-US" smtClean="0"/>
              <a:t>2025/10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90CBD-2EAC-430E-9E04-162544A6F47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71488" y="2636375"/>
            <a:ext cx="2914650" cy="628374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71863" y="2636375"/>
            <a:ext cx="2914650" cy="628374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194346-F981-468E-BB97-94E9A093B877}" type="datetimeFigureOut">
              <a:rPr lang="zh-CN" altLang="en-US" smtClean="0"/>
              <a:t>2025/10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90CBD-2EAC-430E-9E04-162544A6F47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527275"/>
            <a:ext cx="5915025" cy="1914238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2381" y="2427758"/>
            <a:ext cx="2901255" cy="118980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72381" y="3617565"/>
            <a:ext cx="2901255" cy="532089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71863" y="2427758"/>
            <a:ext cx="2915543" cy="118980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71863" y="3617565"/>
            <a:ext cx="2915543" cy="532089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194346-F981-468E-BB97-94E9A093B877}" type="datetimeFigureOut">
              <a:rPr lang="zh-CN" altLang="en-US" smtClean="0"/>
              <a:t>2025/10/2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90CBD-2EAC-430E-9E04-162544A6F47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194346-F981-468E-BB97-94E9A093B877}" type="datetimeFigureOut">
              <a:rPr lang="zh-CN" altLang="en-US" smtClean="0"/>
              <a:t>2025/10/2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90CBD-2EAC-430E-9E04-162544A6F47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194346-F981-468E-BB97-94E9A093B877}" type="datetimeFigureOut">
              <a:rPr lang="zh-CN" altLang="en-US" smtClean="0"/>
              <a:t>2025/10/2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90CBD-2EAC-430E-9E04-162544A6F47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60240"/>
            <a:ext cx="2211883" cy="231084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915543" y="1425935"/>
            <a:ext cx="3471863" cy="703797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971080"/>
            <a:ext cx="2211883" cy="5504293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194346-F981-468E-BB97-94E9A093B877}" type="datetimeFigureOut">
              <a:rPr lang="zh-CN" altLang="en-US" smtClean="0"/>
              <a:t>2025/10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90CBD-2EAC-430E-9E04-162544A6F47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60240"/>
            <a:ext cx="2211883" cy="231084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915543" y="1425935"/>
            <a:ext cx="3471863" cy="703797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971080"/>
            <a:ext cx="2211883" cy="5504293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194346-F981-468E-BB97-94E9A093B877}" type="datetimeFigureOut">
              <a:rPr lang="zh-CN" altLang="en-US" smtClean="0"/>
              <a:t>2025/10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90CBD-2EAC-430E-9E04-162544A6F47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71488" y="527275"/>
            <a:ext cx="5915025" cy="191423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1488" y="2636375"/>
            <a:ext cx="5915025" cy="628374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71488" y="9179170"/>
            <a:ext cx="1543050" cy="5272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194346-F981-468E-BB97-94E9A093B877}" type="datetimeFigureOut">
              <a:rPr lang="zh-CN" altLang="en-US" smtClean="0"/>
              <a:t>2025/10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271713" y="9179170"/>
            <a:ext cx="2314575" cy="5272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843463" y="9179170"/>
            <a:ext cx="1543050" cy="5272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190CBD-2EAC-430E-9E04-162544A6F47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4515" y="1541059"/>
            <a:ext cx="3960000" cy="1587608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64515" y="3128667"/>
            <a:ext cx="3600000" cy="1891123"/>
          </a:xfrm>
          <a:prstGeom prst="rect">
            <a:avLst/>
          </a:prstGeom>
        </p:spPr>
      </p:pic>
      <p:sp>
        <p:nvSpPr>
          <p:cNvPr id="8" name="文本框 1"/>
          <p:cNvSpPr txBox="1"/>
          <p:nvPr/>
        </p:nvSpPr>
        <p:spPr>
          <a:xfrm>
            <a:off x="1103126" y="5322725"/>
            <a:ext cx="509420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1.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6 isolates were randomly selected from the </a:t>
            </a:r>
            <a:r>
              <a:rPr lang="en-US" altLang="zh-CN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Den3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strains for supplementary pathogenicity </a:t>
            </a:r>
            <a:r>
              <a:rPr lang="en-US" altLang="zh-CN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testing.</a:t>
            </a:r>
            <a:endParaRPr lang="en-US" altLang="zh-CN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377641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2"/>
          <a:srcRect/>
          <a:stretch>
            <a:fillRect/>
          </a:stretch>
        </p:blipFill>
        <p:spPr>
          <a:xfrm>
            <a:off x="1706146" y="1692668"/>
            <a:ext cx="3392402" cy="4449052"/>
          </a:xfrm>
          <a:prstGeom prst="rect">
            <a:avLst/>
          </a:prstGeom>
        </p:spPr>
      </p:pic>
      <p:sp>
        <p:nvSpPr>
          <p:cNvPr id="3" name="文本框 1"/>
          <p:cNvSpPr txBox="1"/>
          <p:nvPr/>
        </p:nvSpPr>
        <p:spPr>
          <a:xfrm>
            <a:off x="956169" y="6754197"/>
            <a:ext cx="509420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2.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Overall qualitative </a:t>
            </a:r>
            <a:r>
              <a:rPr lang="en-US" altLang="zh-CN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nalysis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of the metabolomics data.</a:t>
            </a:r>
          </a:p>
        </p:txBody>
      </p:sp>
    </p:spTree>
    <p:extLst>
      <p:ext uri="{BB962C8B-B14F-4D97-AF65-F5344CB8AC3E}">
        <p14:creationId xmlns:p14="http://schemas.microsoft.com/office/powerpoint/2010/main" val="17262810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2"/>
          <a:srcRect t="12633"/>
          <a:stretch/>
        </p:blipFill>
        <p:spPr>
          <a:xfrm>
            <a:off x="1502908" y="1287574"/>
            <a:ext cx="3218963" cy="4053016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1113547" y="5434076"/>
            <a:ext cx="5153649" cy="21852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S3. </a:t>
            </a:r>
            <a:r>
              <a: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Flavonoid biosynthesis pathway related DEGs in CK and IN.</a:t>
            </a:r>
          </a:p>
          <a:p>
            <a:r>
              <a: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LOC110093920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	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dihydroflavonol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4-reductase isoform X1 </a:t>
            </a:r>
            <a:r>
              <a: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lang="en-US" altLang="zh-CN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ndrobium</a:t>
            </a:r>
            <a:r>
              <a: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tenatum</a:t>
            </a:r>
            <a:r>
              <a: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</a:p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LOC110101655	Dihydroflavonol-4-reductase [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Dendrobium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catenatum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</a:p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LOC110111528	Dihydroflavonol-4-reductase [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Dendrobium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catenatum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</a:p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LOC110097388	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flavanone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3-dioxygenase [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Dendrobium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catenatum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</a:p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LOC110103723	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Leucoanthocyanidin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dioxygenase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[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Dendrobium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catenatum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</a:p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LOC110099164	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chalcone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--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flavonone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isomerase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-like [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Dendrobium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catenatum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</a:p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novel.6895	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naringenin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3-dioxygenase [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Bromheadia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finlaysoniana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</a:p>
          <a:p>
            <a:endParaRPr lang="en-US" altLang="zh-CN" sz="8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LOC110097219	</a:t>
            </a:r>
            <a:r>
              <a:rPr lang="en-US" altLang="zh-CN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lavonol</a:t>
            </a:r>
            <a:r>
              <a: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synthase/</a:t>
            </a:r>
            <a:r>
              <a:rPr lang="en-US" altLang="zh-CN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lavanone</a:t>
            </a:r>
            <a:r>
              <a: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3-hydroxylase-like [</a:t>
            </a:r>
            <a:r>
              <a:rPr lang="en-US" altLang="zh-CN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ndrobium</a:t>
            </a:r>
            <a:r>
              <a: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tenatum</a:t>
            </a:r>
            <a:r>
              <a: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</a:p>
          <a:p>
            <a:r>
              <a: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LOC110105072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	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bibenzyl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synthase-like [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Dendrobium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catenatum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</a:p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LOC110105073	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Bibenzyl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synthase [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Dendrobium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catenatum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</a:p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LOC110107557	probable 2-oxoglutarate-dependent </a:t>
            </a:r>
            <a:r>
              <a:rPr lang="en-US" altLang="zh-CN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ioxygenase</a:t>
            </a:r>
            <a:r>
              <a: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[</a:t>
            </a:r>
            <a:r>
              <a:rPr lang="en-US" altLang="zh-CN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ndrobium</a:t>
            </a:r>
            <a:r>
              <a: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catenatum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</a:p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LOC110107833	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chalcone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synthase 8-like [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Dendrobium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catenatum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</a:p>
          <a:p>
            <a:r>
              <a: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LOC110115253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	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bibenzyl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synthase-like [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Dendrobium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catenatum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</a:p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novel.11606	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flavonol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synthase/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flavanone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3-hydroxylase-like [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Dendrobium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catenatum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</a:p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novel.11877	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bibenzyl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synthase-like [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Dendrobium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catenatum</a:t>
            </a:r>
            <a:r>
              <a: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684831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2"/>
          <a:srcRect l="-301" t="12810" r="301" b="753"/>
          <a:stretch/>
        </p:blipFill>
        <p:spPr>
          <a:xfrm>
            <a:off x="1296670" y="2123439"/>
            <a:ext cx="4440359" cy="3068321"/>
          </a:xfrm>
          <a:prstGeom prst="rect">
            <a:avLst/>
          </a:prstGeom>
        </p:spPr>
      </p:pic>
      <p:sp>
        <p:nvSpPr>
          <p:cNvPr id="4" name="文本框 1"/>
          <p:cNvSpPr txBox="1"/>
          <p:nvPr/>
        </p:nvSpPr>
        <p:spPr>
          <a:xfrm>
            <a:off x="879969" y="5524837"/>
            <a:ext cx="509420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5.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Flavonoid biosynthesis pathway related </a:t>
            </a:r>
            <a:r>
              <a:rPr lang="en-US" altLang="zh-CN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DAMs in M-CK and M-IN.</a:t>
            </a:r>
            <a:endParaRPr lang="en-US" altLang="zh-CN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altLang="zh-CN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1417270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 4"/>
          <p:cNvSpPr/>
          <p:nvPr/>
        </p:nvSpPr>
        <p:spPr>
          <a:xfrm>
            <a:off x="1301032" y="5324635"/>
            <a:ext cx="5004352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85800"/>
            <a:r>
              <a:rPr lang="en-US" altLang="zh-CN" sz="110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1100" smtClean="0">
                <a:latin typeface="Arial" panose="020B0604020202020204" pitchFamily="34" charset="0"/>
                <a:cs typeface="Arial" panose="020B0604020202020204" pitchFamily="34" charset="0"/>
              </a:rPr>
              <a:t>S5.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Phospholipase activity and gene expression dynamics during </a:t>
            </a:r>
            <a:r>
              <a:rPr lang="en-US" altLang="zh-CN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nfection. </a:t>
            </a:r>
            <a:r>
              <a:rPr lang="en-US" altLang="zh-CN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,Total</a:t>
            </a:r>
            <a:r>
              <a:rPr lang="en-US" altLang="zh-CN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phospholipase activity in healthy (CK) and infected leaves at 5, 15, and 25 dpi. Data are mean ± SD (n=3); **p &lt; 0.01, ***p &lt; 0.001 vs. </a:t>
            </a:r>
            <a:r>
              <a:rPr lang="en-US" altLang="zh-CN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K. </a:t>
            </a:r>
            <a:r>
              <a:rPr lang="en-US" altLang="zh-CN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,c</a:t>
            </a:r>
            <a:r>
              <a:rPr lang="en-US" altLang="zh-CN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, Relative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expression of host PLA and pathogen PLA2 genes at 5, 15, and 25 dpi, normalized to Actin (host) or β-tubulin (pathogen). Values are mean ± SD (n=3); different letters indicate significant differences (p &lt; 0.05) by </a:t>
            </a:r>
            <a:r>
              <a:rPr lang="en-US" altLang="zh-CN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tudent’s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test.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64174" y="1148840"/>
            <a:ext cx="2487384" cy="2152075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42836" y="3322186"/>
            <a:ext cx="2530059" cy="2152075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30060" y="3354149"/>
            <a:ext cx="2493480" cy="2152075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1144579" y="865307"/>
            <a:ext cx="31290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dirty="0"/>
          </a:p>
        </p:txBody>
      </p:sp>
      <p:sp>
        <p:nvSpPr>
          <p:cNvPr id="11" name="矩形 10"/>
          <p:cNvSpPr/>
          <p:nvPr/>
        </p:nvSpPr>
        <p:spPr>
          <a:xfrm>
            <a:off x="1144579" y="3116249"/>
            <a:ext cx="31290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dirty="0"/>
          </a:p>
        </p:txBody>
      </p:sp>
      <p:sp>
        <p:nvSpPr>
          <p:cNvPr id="12" name="矩形 11"/>
          <p:cNvSpPr/>
          <p:nvPr/>
        </p:nvSpPr>
        <p:spPr>
          <a:xfrm>
            <a:off x="3608723" y="3116249"/>
            <a:ext cx="3000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0229838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16</TotalTime>
  <Words>165</Words>
  <Application>Microsoft Office PowerPoint</Application>
  <PresentationFormat>自定义</PresentationFormat>
  <Paragraphs>25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0" baseType="lpstr">
      <vt:lpstr>宋体</vt:lpstr>
      <vt:lpstr>Arial</vt:lpstr>
      <vt:lpstr>Calibri</vt:lpstr>
      <vt:lpstr>Calibri Light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>Mico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orosoft</dc:creator>
  <cp:lastModifiedBy>joe</cp:lastModifiedBy>
  <cp:revision>45</cp:revision>
  <dcterms:created xsi:type="dcterms:W3CDTF">2021-04-02T13:08:00Z</dcterms:created>
  <dcterms:modified xsi:type="dcterms:W3CDTF">2025-10-28T08:05:2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7311</vt:lpwstr>
  </property>
</Properties>
</file>